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524" y="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605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344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0535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460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235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499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217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410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274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968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225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2BCDAB-40BE-437E-90D8-04808C05C283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55D442-3A7E-44E0-BE7A-08C84D5206D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3501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uppo 14"/>
          <p:cNvGrpSpPr/>
          <p:nvPr/>
        </p:nvGrpSpPr>
        <p:grpSpPr>
          <a:xfrm>
            <a:off x="856929" y="1306851"/>
            <a:ext cx="277091" cy="3114615"/>
            <a:chOff x="333022" y="530578"/>
            <a:chExt cx="304800" cy="3426076"/>
          </a:xfrm>
        </p:grpSpPr>
        <p:sp>
          <p:nvSpPr>
            <p:cNvPr id="12" name="CasellaDiTesto 11"/>
            <p:cNvSpPr txBox="1"/>
            <p:nvPr/>
          </p:nvSpPr>
          <p:spPr>
            <a:xfrm>
              <a:off x="333022" y="530578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A</a:t>
              </a:r>
              <a:endParaRPr lang="en-US" sz="1200" dirty="0"/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333022" y="3651955"/>
              <a:ext cx="304800" cy="3046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B</a:t>
              </a:r>
              <a:endParaRPr lang="en-US" sz="1200" dirty="0"/>
            </a:p>
          </p:txBody>
        </p:sp>
      </p:grpSp>
      <p:sp>
        <p:nvSpPr>
          <p:cNvPr id="16" name="CasellaDiTesto 15"/>
          <p:cNvSpPr txBox="1"/>
          <p:nvPr/>
        </p:nvSpPr>
        <p:spPr>
          <a:xfrm>
            <a:off x="221974" y="193138"/>
            <a:ext cx="117480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: </a:t>
            </a:r>
            <a:r>
              <a:rPr lang="en-GB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DA scores of </a:t>
            </a:r>
            <a:r>
              <a:rPr lang="en-GB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fSe</a:t>
            </a:r>
            <a:r>
              <a:rPr lang="en-GB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mparison analysis between control and groups treated at 21 days of age for three consecutive days. A) 1 day post treatment (d.p.t) and B) 9 d.p.t.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Immagine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58668"/>
            <a:ext cx="12192000" cy="2235200"/>
          </a:xfrm>
          <a:prstGeom prst="rect">
            <a:avLst/>
          </a:prstGeom>
        </p:spPr>
      </p:pic>
      <p:pic>
        <p:nvPicPr>
          <p:cNvPr id="18" name="Immagine 1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9292" y="4144467"/>
            <a:ext cx="6400813" cy="25146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53750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43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>Università degli Studi di Pado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coni Andrea</dc:creator>
  <cp:lastModifiedBy>Laconi Andrea</cp:lastModifiedBy>
  <cp:revision>4</cp:revision>
  <dcterms:created xsi:type="dcterms:W3CDTF">2022-06-10T13:51:42Z</dcterms:created>
  <dcterms:modified xsi:type="dcterms:W3CDTF">2022-06-10T15:12:20Z</dcterms:modified>
</cp:coreProperties>
</file>